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  <Override PartName="/ppt/comments/comment5.xml" ContentType="application/vnd.openxmlformats-officedocument.presentationml.comments+xml"/>
  <Override PartName="/ppt/commentAuthors.xml" ContentType="application/vnd.openxmlformats-officedocument.presentationml.commentAuthor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</p:sldIdLst>
  <p:sldSz cx="9144000" cy="6858000"/>
  <p:notesSz cx="6858000" cy="9144000"/>
</p:presentation>
</file>

<file path=ppt/commentAuthors.xml><?xml version="1.0" encoding="utf-8"?>
<p:cmAuthorLst xmlns:p="http://schemas.openxmlformats.org/presentationml/2006/main">
  <p:cmAuthor id="0" name="CLIFFORD BLOCK" initials="CB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presProps" Target="presProps.xml"/><Relationship Id="rId25" Type="http://schemas.openxmlformats.org/officeDocument/2006/relationships/commentAuthors" Target="commentAuthors.xml"/>
</Relationships>
</file>

<file path=ppt/comments/comment5.xml><?xml version="1.0" encoding="utf-8"?>
<p:cmLst xmlns:p="http://schemas.openxmlformats.org/presentationml/2006/main">
  <p:cm authorId="0" dt="2006-10-30T19:14:47.812000000" idx="1">
    <p:pos x="5376" y="1200"/>
    <p:text>Mention--can sign up family members, as example of social support</p:text>
  </p:cm>
</p:cmLst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FA19E-4AE4-4911-BC9E-CEC2074304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A82EC-55C5-41B8-BCD4-3DF24D7AB7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0E6D1-BCD9-4F31-A0D2-2A100EE6BF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75B51-4908-4FC4-AEB1-F4E04AAEAA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B7970-C36C-46A9-B74D-A769BFEA7F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B6D45-30E5-43AF-B7F4-AECB3A53E6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16F0B-5223-4CC7-A21F-88B9318D71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77E22-546B-45F8-87EA-2C6A9052A4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A9C032-FEB8-4FAA-8E12-45CC5BFDFD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1F55E5-1D73-47E9-82A6-D75870CA49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FF1C68-A63A-432C-B293-58958DD150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5BB95-5B5B-4D04-B84F-93C858A7B0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BC7EA9-640D-4AA2-BF11-7C96DECBCD6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nutritionquest.com/" TargetMode="Externa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comments" Target="../comments/comment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80880" y="3809880"/>
            <a:ext cx="838224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0000"/>
                </a:solidFill>
                <a:latin typeface="Arial"/>
              </a:rPr>
              <a:t>A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4400" spc="-1" strike="noStrike">
                <a:solidFill>
                  <a:srgbClr val="ff3300"/>
                </a:solidFill>
                <a:latin typeface="Arial"/>
              </a:rPr>
              <a:t>L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ifestyle </a:t>
            </a:r>
            <a:r>
              <a:rPr b="0" lang="en-US" sz="4400" spc="-1" strike="noStrike">
                <a:solidFill>
                  <a:srgbClr val="ff3300"/>
                </a:solidFill>
                <a:latin typeface="Arial"/>
              </a:rPr>
              <a:t>I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ntervention </a:t>
            </a:r>
            <a:r>
              <a:rPr b="0" lang="en-US" sz="4400" spc="-1" strike="noStrike">
                <a:solidFill>
                  <a:srgbClr val="ff3300"/>
                </a:solidFill>
                <a:latin typeface="Arial"/>
              </a:rPr>
              <a:t>V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ia </a:t>
            </a:r>
            <a:r>
              <a:rPr b="0" lang="en-US" sz="4400" spc="-1" strike="noStrike">
                <a:solidFill>
                  <a:srgbClr val="ff3300"/>
                </a:solidFill>
                <a:latin typeface="Arial"/>
              </a:rPr>
              <a:t>E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il</a:t>
            </a:r>
            <a:br>
              <a:rPr sz="4400"/>
            </a:br>
            <a:br>
              <a:rPr sz="4400"/>
            </a:br>
            <a:r>
              <a:rPr b="0" lang="en-US" sz="24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www.nutritionquest.com</a:t>
            </a:r>
            <a:br>
              <a:rPr sz="32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510-704-851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2362320" y="838080"/>
            <a:ext cx="4351320" cy="2681280"/>
          </a:xfrm>
          <a:prstGeom prst="rect">
            <a:avLst/>
          </a:prstGeom>
          <a:ln w="0">
            <a:noFill/>
          </a:ln>
        </p:spPr>
      </p:pic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1371600" y="274320"/>
            <a:ext cx="7315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First Step: </a:t>
            </a:r>
            <a:br>
              <a:rPr sz="4000"/>
            </a:b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Health Risk Assessmen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523880"/>
            <a:ext cx="8229600" cy="50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Diet and physical activity screener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Available to all, whether they decide to participate in the full program or no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ompleted online in about 15 minut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stant feedback on </a:t>
            </a:r>
            <a:r>
              <a:rPr b="0" lang="en-US" sz="2800" spc="-1" strike="noStrike" u="sng">
                <a:solidFill>
                  <a:srgbClr val="000000"/>
                </a:solidFill>
                <a:uFillTx/>
                <a:latin typeface="Arial"/>
              </a:rPr>
              <a:t>individual’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aturated and trans fat intake, sugar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ruit &amp; vegetable intak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Physical activity and sedentary behavio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249120" y="304920"/>
            <a:ext cx="1787760" cy="1096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304920" y="228600"/>
            <a:ext cx="8528040" cy="63961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2437920" y="274320"/>
            <a:ext cx="62485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Instant Feedback from Screener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828440"/>
            <a:ext cx="8229600" cy="4297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 u="sng">
                <a:solidFill>
                  <a:srgbClr val="000000"/>
                </a:solidFill>
                <a:uFillTx/>
                <a:latin typeface="Arial"/>
              </a:rPr>
              <a:t>Personalizes</a:t>
            </a: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 the need for improvemen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aturated and trans fat intake, sugar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ruit &amp; vegetable intak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Physical activity and sedentary behavior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 relation to national recommendation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249120" y="304920"/>
            <a:ext cx="1787760" cy="1096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301680" y="227160"/>
            <a:ext cx="8528040" cy="6395760"/>
          </a:xfrm>
          <a:prstGeom prst="rect">
            <a:avLst/>
          </a:prstGeom>
          <a:ln w="0">
            <a:noFill/>
          </a:ln>
        </p:spPr>
      </p:pic>
    </p:spTree>
  </p:cSld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2133360" y="274320"/>
            <a:ext cx="65530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Next Step:</a:t>
            </a:r>
            <a:br>
              <a:rPr sz="4000"/>
            </a:b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hoose your Big Goa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457200" y="17524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hoose one to work on for next 12 week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crease physical activity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Decrease saturated &amp; trans fats &amp; added sugar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crease fruits and vegetabl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an cover all three topics over a year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" descr=""/>
          <p:cNvPicPr/>
          <p:nvPr/>
        </p:nvPicPr>
        <p:blipFill>
          <a:blip r:embed="rId1"/>
          <a:stretch/>
        </p:blipFill>
        <p:spPr>
          <a:xfrm>
            <a:off x="249120" y="304920"/>
            <a:ext cx="1787760" cy="1096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2057040" y="274320"/>
            <a:ext cx="6629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Next Step:</a:t>
            </a:r>
            <a:br>
              <a:rPr sz="3600"/>
            </a:b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Tailoring Questionnaire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457200" y="2057040"/>
            <a:ext cx="8229600" cy="426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Goals and tips are </a:t>
            </a:r>
            <a:r>
              <a:rPr b="0" lang="en-US" sz="3200" spc="-1" strike="noStrike" u="sng">
                <a:solidFill>
                  <a:srgbClr val="000000"/>
                </a:solidFill>
                <a:uFillTx/>
                <a:latin typeface="Arial"/>
              </a:rPr>
              <a:t>tailore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pecific foods reported in diet screener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Who does the cooking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Kids at home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at out a lot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Prefer exercise structured or around home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tage of physical activity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" descr=""/>
          <p:cNvPicPr/>
          <p:nvPr/>
        </p:nvPicPr>
        <p:blipFill>
          <a:blip r:embed="rId1"/>
          <a:stretch/>
        </p:blipFill>
        <p:spPr>
          <a:xfrm>
            <a:off x="249120" y="304920"/>
            <a:ext cx="1787760" cy="1096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1905120" y="274320"/>
            <a:ext cx="67816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Weekly email messag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Directly to email inbox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ontai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 </a:t>
            </a:r>
            <a:r>
              <a:rPr b="0" i="1" lang="en-US" sz="2800" spc="-1" strike="noStrike">
                <a:solidFill>
                  <a:srgbClr val="000000"/>
                </a:solidFill>
                <a:latin typeface="Arial"/>
              </a:rPr>
              <a:t>tailored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goals to choose from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ummary of the week’s Health Not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249120" y="304920"/>
            <a:ext cx="1787760" cy="1096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301680" y="227160"/>
            <a:ext cx="8528040" cy="6395760"/>
          </a:xfrm>
          <a:prstGeom prst="rect">
            <a:avLst/>
          </a:prstGeom>
          <a:ln w="0">
            <a:noFill/>
          </a:ln>
        </p:spPr>
      </p:pic>
    </p:spTree>
  </p:cSld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2209680" y="274320"/>
            <a:ext cx="6477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licking to choose a weekly small-step goal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533520" y="198108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akes you to your Personal Home Page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Automatically. No need for participant to decide whether or not to visit web pag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Home page contai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Restating of small-step goal you cho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ailored tips for achieving that goa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Numerous other opportunities for interactio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" descr=""/>
          <p:cNvPicPr/>
          <p:nvPr/>
        </p:nvPicPr>
        <p:blipFill>
          <a:blip r:embed="rId1"/>
          <a:stretch/>
        </p:blipFill>
        <p:spPr>
          <a:xfrm>
            <a:off x="249120" y="304920"/>
            <a:ext cx="1787760" cy="1096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301680" y="227160"/>
            <a:ext cx="8528040" cy="6395760"/>
          </a:xfrm>
          <a:prstGeom prst="rect">
            <a:avLst/>
          </a:prstGeom>
          <a:ln w="0">
            <a:noFill/>
          </a:ln>
        </p:spPr>
      </p:pic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/>
          </p:nvPr>
        </p:nvSpPr>
        <p:spPr>
          <a:xfrm>
            <a:off x="456840" y="2285640"/>
            <a:ext cx="845820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900" spc="-1" strike="noStrike">
                <a:solidFill>
                  <a:srgbClr val="000000"/>
                </a:solidFill>
                <a:latin typeface="Arial"/>
              </a:rPr>
              <a:t>Developed by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900" spc="-1" strike="noStrike">
                <a:solidFill>
                  <a:srgbClr val="000000"/>
                </a:solidFill>
                <a:latin typeface="Arial"/>
              </a:rPr>
              <a:t>Block Dietary Data Systems, Berkeley, CA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Gladys Block, PhD; Clifford Block, PhD; Torin Block; Jean Norris, DrPH; Donald Hopkin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900" spc="-1" strike="noStrike">
                <a:solidFill>
                  <a:srgbClr val="000000"/>
                </a:solidFill>
                <a:latin typeface="Arial"/>
              </a:rPr>
              <a:t>Kaiser Permanente Division of Research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Barbara Sternfeld, PhD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7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900" spc="-1" strike="noStrike">
                <a:solidFill>
                  <a:srgbClr val="000000"/>
                </a:solidFill>
                <a:latin typeface="Arial"/>
              </a:rPr>
              <a:t>Tested in randomized trial in a worksite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0000"/>
              </a:lnSpc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900" spc="-1" strike="noStrike">
                <a:solidFill>
                  <a:srgbClr val="000000"/>
                </a:solidFill>
                <a:latin typeface="Arial"/>
              </a:rPr>
              <a:t>Significant behavior change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533520" y="304920"/>
            <a:ext cx="2179440" cy="134136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2971800" y="304920"/>
            <a:ext cx="571500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22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An intervention to improve Nutrition and </a:t>
            </a:r>
            <a:br>
              <a:rPr sz="3600"/>
            </a:b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Physical Activity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Tools on the Personal Home Page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" descr=""/>
          <p:cNvPicPr/>
          <p:nvPr/>
        </p:nvPicPr>
        <p:blipFill>
          <a:blip r:embed="rId1"/>
          <a:srcRect l="4688" t="24620" r="73443" b="31255"/>
          <a:stretch/>
        </p:blipFill>
        <p:spPr>
          <a:xfrm>
            <a:off x="2362320" y="1295280"/>
            <a:ext cx="3525840" cy="5334120"/>
          </a:xfrm>
          <a:prstGeom prst="rect">
            <a:avLst/>
          </a:prstGeom>
          <a:ln w="0">
            <a:noFill/>
          </a:ln>
        </p:spPr>
      </p:pic>
    </p:spTree>
  </p:cSld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2590560" y="274680"/>
            <a:ext cx="6095880" cy="86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Arial"/>
              </a:rPr>
              <a:t>What’s Uniqu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228600" y="1371240"/>
            <a:ext cx="8686800" cy="5181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4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000000"/>
                </a:solidFill>
                <a:uFillTx/>
                <a:latin typeface="Arial"/>
              </a:rPr>
              <a:t>Proven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dietary and physical activity behavior change in randomized tria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4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dditional effects on quality of life and presenteeism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4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ow cos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4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No administrative burden on employer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4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ighly tailored interventio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4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ntervention comes to the participant – no need for participant to actively seek i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" descr=""/>
          <p:cNvPicPr/>
          <p:nvPr/>
        </p:nvPicPr>
        <p:blipFill>
          <a:blip r:embed="rId1"/>
          <a:stretch/>
        </p:blipFill>
        <p:spPr>
          <a:xfrm>
            <a:off x="533520" y="304920"/>
            <a:ext cx="1904760" cy="1172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2590920" y="274680"/>
            <a:ext cx="6324480" cy="86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Arial"/>
              </a:rPr>
              <a:t>Potential Uses of </a:t>
            </a:r>
            <a:r>
              <a:rPr b="1" i="1" lang="en-US" sz="4000" spc="-1" strike="noStrike">
                <a:solidFill>
                  <a:srgbClr val="000000"/>
                </a:solidFill>
                <a:latin typeface="Arial"/>
              </a:rPr>
              <a:t>ALIVE!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456840" y="1371600"/>
            <a:ext cx="845820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By employers, for their employee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By organizations, for their member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By researchers, for their research subject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Aft>
                <a:spcPts val="1199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Used as a self-contained stand-alone interven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Aft>
                <a:spcPts val="1199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Used as an adjunct to other, more hands-on, interventio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Aft>
                <a:spcPts val="1049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creases participation, maintains awarenes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533520" y="304920"/>
            <a:ext cx="1828800" cy="1125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2437920" y="304560"/>
            <a:ext cx="57913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Behavioral Goals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456840" y="1752480"/>
            <a:ext cx="7924680" cy="472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crease physical activity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Decrease saturated and trans fats, decrease added sugars, increase good fats and carb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crease fruit and vegetable intak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 u="sng">
                <a:solidFill>
                  <a:srgbClr val="000000"/>
                </a:solidFill>
                <a:uFillTx/>
                <a:latin typeface="Arial"/>
              </a:rPr>
              <a:t>Not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a weight loss program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an be adapted to other intervention outcom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685800" y="304920"/>
            <a:ext cx="1787400" cy="109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2209680" y="380520"/>
            <a:ext cx="64771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Behavior Change Principles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380520" y="1371240"/>
            <a:ext cx="815364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7000"/>
          </a:bodyPr>
          <a:p>
            <a:pPr marL="332640" indent="-332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Maximizing individual </a:t>
            </a: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relevance-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-through assessments, feedback and tailoring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Tailoring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to stage-of-change, individual diet habits, exercise preferenc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Goal setting</a:t>
            </a: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mall-steps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toward new habit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ontinued </a:t>
            </a: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eedback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and reinforcement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Increasing </a:t>
            </a: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alience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 and motivation through health information, tips and reminder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2640" indent="-332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Encouraging </a:t>
            </a: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ocial suppor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3264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538200" y="328680"/>
            <a:ext cx="1787400" cy="109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2590560" y="304560"/>
            <a:ext cx="5257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omponent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80880" y="1371240"/>
            <a:ext cx="822960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Weekly messages contai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ggested goals to try for the week, 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</a:rPr>
              <a:t>tailored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to each individua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ips for achieving the selected goal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ips for overcoming barrier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ealth information, information on nutrition and physical activit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nteractive tool to explore effects of specific chang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inks to other health/nutrition sit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inks to track diet and physical activit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More!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638280" y="304920"/>
            <a:ext cx="1787400" cy="109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2590560" y="304560"/>
            <a:ext cx="5257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ome “Health Notes” Topics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38088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arbs and the Glycemic Inde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ruits, Veggies and Cance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Physical Activity and Breast Cance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Diet and Cognitive Functio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Mood, Stress and Physical Activity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omponents of Fitnes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rends in Physical Activity Program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“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Good” Fats, “Bad” Fat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nd many other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638280" y="304920"/>
            <a:ext cx="1787400" cy="109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2666880" y="274320"/>
            <a:ext cx="60199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How the process begins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380520" y="1676520"/>
            <a:ext cx="815364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Email is sent by the organization or company, or researcher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Batch email, to organization’s target group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533520" y="338040"/>
            <a:ext cx="1787400" cy="1096920"/>
          </a:xfrm>
          <a:prstGeom prst="rect">
            <a:avLst/>
          </a:prstGeom>
          <a:ln w="0">
            <a:noFill/>
          </a:ln>
        </p:spPr>
      </p:pic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457200" y="380880"/>
            <a:ext cx="8229600" cy="624852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5T02:48:57Z</dcterms:created>
  <dc:creator>Gladys Block</dc:creator>
  <dc:description/>
  <dc:language>en-US</dc:language>
  <cp:lastModifiedBy>Gladys Block</cp:lastModifiedBy>
  <dcterms:modified xsi:type="dcterms:W3CDTF">2008-07-05T03:01:55Z</dcterms:modified>
  <cp:revision>1</cp:revision>
  <dc:subject/>
  <dc:title>A Lifestyle Intervention Via Email  www.nutritionquest.com 510-704-8514</dc:title>
</cp:coreProperties>
</file>